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3.bin" ContentType="application/vnd.openxmlformats-officedocument.oleObject"/>
  <Override PartName="/ppt/embeddings/oleObject12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media/image9.wmf" ContentType="image/x-wmf"/>
  <Override PartName="/ppt/media/image8.wmf" ContentType="image/x-wmf"/>
  <Override PartName="/ppt/media/image13.png" ContentType="image/png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11.png" ContentType="image/png"/>
  <Override PartName="/ppt/media/image6.wmf" ContentType="image/x-wmf"/>
  <Override PartName="/ppt/media/image12.png" ContentType="image/png"/>
  <Override PartName="/ppt/media/image7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EA03E-0CAE-4B7D-9576-E4C3197698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54BE7-6F80-42FD-9B3B-4444FD2B83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80F57-D369-4FA8-9A93-BE5BE45A37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A429DF-1B0A-48B9-BCF4-0B73233D02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A1145A-38F8-4EE0-9261-FEA4697BCF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74FAD-C240-4377-A69B-D731E69E4F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CDCD91-AE57-4BDC-815E-AD8706EE38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EB579-D395-4502-8EFC-F9FDCDB47E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46779-AF1D-4A46-B683-70DF81F883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9A7E3-CE23-44F6-830E-5B759F795E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EA6A4-7CB7-411A-9AAA-989A99457B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C4A48-9F71-4A7C-9BAC-7125BA9F20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DF0AF2-AD1B-498A-9105-9EDCE1BC378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wmf"/><Relationship Id="rId21" Type="http://schemas.openxmlformats.org/officeDocument/2006/relationships/image" Target="../media/image11.png"/><Relationship Id="rId22" Type="http://schemas.openxmlformats.org/officeDocument/2006/relationships/image" Target="../media/image11.png"/><Relationship Id="rId23" Type="http://schemas.openxmlformats.org/officeDocument/2006/relationships/image" Target="../media/image11.png"/><Relationship Id="rId24" Type="http://schemas.openxmlformats.org/officeDocument/2006/relationships/image" Target="../media/image12.png"/><Relationship Id="rId25" Type="http://schemas.openxmlformats.org/officeDocument/2006/relationships/image" Target="../media/image13.png"/><Relationship Id="rId26" Type="http://schemas.openxmlformats.org/officeDocument/2006/relationships/image" Target="../media/image13.png"/><Relationship Id="rId27" Type="http://schemas.openxmlformats.org/officeDocument/2006/relationships/image" Target="../media/image13.png"/><Relationship Id="rId28" Type="http://schemas.openxmlformats.org/officeDocument/2006/relationships/oleObject" Target="../embeddings/oleObject11.bin"/><Relationship Id="rId29" Type="http://schemas.openxmlformats.org/officeDocument/2006/relationships/image" Target="../media/image14.wmf"/><Relationship Id="rId30" Type="http://schemas.openxmlformats.org/officeDocument/2006/relationships/oleObject" Target="../embeddings/oleObject12.bin"/><Relationship Id="rId31" Type="http://schemas.openxmlformats.org/officeDocument/2006/relationships/image" Target="../media/image15.wmf"/><Relationship Id="rId32" Type="http://schemas.openxmlformats.org/officeDocument/2006/relationships/oleObject" Target="../embeddings/oleObject13.bin"/><Relationship Id="rId33" Type="http://schemas.openxmlformats.org/officeDocument/2006/relationships/image" Target="../media/image16.wmf"/><Relationship Id="rId34" Type="http://schemas.openxmlformats.org/officeDocument/2006/relationships/oleObject" Target="../embeddings/oleObject14.bin"/><Relationship Id="rId35" Type="http://schemas.openxmlformats.org/officeDocument/2006/relationships/image" Target="../media/image15.wmf"/><Relationship Id="rId36" Type="http://schemas.openxmlformats.org/officeDocument/2006/relationships/oleObject" Target="../embeddings/oleObject15.bin"/><Relationship Id="rId37" Type="http://schemas.openxmlformats.org/officeDocument/2006/relationships/image" Target="../media/image10.wmf"/><Relationship Id="rId3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06"/>
          <p:cNvSpPr/>
          <p:nvPr/>
        </p:nvSpPr>
        <p:spPr>
          <a:xfrm>
            <a:off x="907920" y="1143000"/>
            <a:ext cx="3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3"/>
          <p:cNvSpPr/>
          <p:nvPr/>
        </p:nvSpPr>
        <p:spPr>
          <a:xfrm>
            <a:off x="4786200" y="3611520"/>
            <a:ext cx="92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mmuniz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06"/>
          <p:cNvSpPr/>
          <p:nvPr/>
        </p:nvSpPr>
        <p:spPr>
          <a:xfrm>
            <a:off x="905040" y="3352680"/>
            <a:ext cx="31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06"/>
          <p:cNvSpPr/>
          <p:nvPr/>
        </p:nvSpPr>
        <p:spPr>
          <a:xfrm>
            <a:off x="905040" y="5257800"/>
            <a:ext cx="31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Object 52"/>
          <p:cNvGraphicFramePr/>
          <p:nvPr/>
        </p:nvGraphicFramePr>
        <p:xfrm>
          <a:off x="3046320" y="8283600"/>
          <a:ext cx="1752840" cy="1393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6" name="Object 5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046320" y="8283600"/>
                    <a:ext cx="1752840" cy="1393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Object 25"/>
          <p:cNvGraphicFramePr/>
          <p:nvPr/>
        </p:nvGraphicFramePr>
        <p:xfrm>
          <a:off x="836640" y="4952880"/>
          <a:ext cx="2666880" cy="24004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8" name="Object 2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836640" y="4952880"/>
                    <a:ext cx="2666880" cy="2400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Object 27"/>
          <p:cNvGraphicFramePr/>
          <p:nvPr/>
        </p:nvGraphicFramePr>
        <p:xfrm>
          <a:off x="836640" y="3048120"/>
          <a:ext cx="2666880" cy="23763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0" name="Object 2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836640" y="3048120"/>
                    <a:ext cx="2666880" cy="2376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Text Box 28"/>
          <p:cNvSpPr/>
          <p:nvPr/>
        </p:nvSpPr>
        <p:spPr>
          <a:xfrm>
            <a:off x="3277080" y="3962520"/>
            <a:ext cx="586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Object 29"/>
          <p:cNvGraphicFramePr/>
          <p:nvPr/>
        </p:nvGraphicFramePr>
        <p:xfrm>
          <a:off x="4722840" y="3886200"/>
          <a:ext cx="1055520" cy="12193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3" name="Object 29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722840" y="3886200"/>
                    <a:ext cx="1055520" cy="1219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4" name="Object 9"/>
          <p:cNvGraphicFramePr/>
          <p:nvPr/>
        </p:nvGraphicFramePr>
        <p:xfrm>
          <a:off x="3656160" y="5410080"/>
          <a:ext cx="1285560" cy="15242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5" name="Object 9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656160" y="5410080"/>
                    <a:ext cx="1285560" cy="1524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6" name="Object 31"/>
          <p:cNvGraphicFramePr/>
          <p:nvPr/>
        </p:nvGraphicFramePr>
        <p:xfrm>
          <a:off x="4646520" y="5410080"/>
          <a:ext cx="1276560" cy="15242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57" name="Object 31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4646520" y="5410080"/>
                    <a:ext cx="1276560" cy="1524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8" name="Text Box 37"/>
          <p:cNvSpPr/>
          <p:nvPr/>
        </p:nvSpPr>
        <p:spPr>
          <a:xfrm>
            <a:off x="3220200" y="5715000"/>
            <a:ext cx="586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8"/>
          <p:cNvSpPr/>
          <p:nvPr/>
        </p:nvSpPr>
        <p:spPr>
          <a:xfrm>
            <a:off x="3220200" y="7620120"/>
            <a:ext cx="586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2"/>
          <p:cNvSpPr/>
          <p:nvPr/>
        </p:nvSpPr>
        <p:spPr>
          <a:xfrm>
            <a:off x="3884400" y="5410080"/>
            <a:ext cx="72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3"/>
          <p:cNvSpPr/>
          <p:nvPr/>
        </p:nvSpPr>
        <p:spPr>
          <a:xfrm>
            <a:off x="4800600" y="5410080"/>
            <a:ext cx="92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mmuniz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32"/>
          <p:cNvSpPr/>
          <p:nvPr/>
        </p:nvSpPr>
        <p:spPr>
          <a:xfrm>
            <a:off x="3884400" y="7238880"/>
            <a:ext cx="72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33"/>
          <p:cNvSpPr/>
          <p:nvPr/>
        </p:nvSpPr>
        <p:spPr>
          <a:xfrm>
            <a:off x="4788000" y="7238880"/>
            <a:ext cx="92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mmuniz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4" name="Object 44"/>
          <p:cNvGraphicFramePr/>
          <p:nvPr/>
        </p:nvGraphicFramePr>
        <p:xfrm>
          <a:off x="836640" y="6934320"/>
          <a:ext cx="2601720" cy="234144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65" name="Object 44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836640" y="6934320"/>
                    <a:ext cx="2601720" cy="234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6" name="Object 46"/>
          <p:cNvGraphicFramePr/>
          <p:nvPr/>
        </p:nvGraphicFramePr>
        <p:xfrm>
          <a:off x="3732120" y="7391520"/>
          <a:ext cx="1143000" cy="129528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67" name="Object 46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732120" y="7391520"/>
                    <a:ext cx="1143000" cy="129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8" name="Object 47"/>
          <p:cNvGraphicFramePr/>
          <p:nvPr/>
        </p:nvGraphicFramePr>
        <p:xfrm>
          <a:off x="4722840" y="7315200"/>
          <a:ext cx="1144440" cy="137160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69" name="Object 47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4722840" y="7315200"/>
                    <a:ext cx="1144440" cy="137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0" name="Text Box 606"/>
          <p:cNvSpPr/>
          <p:nvPr/>
        </p:nvSpPr>
        <p:spPr>
          <a:xfrm>
            <a:off x="4494240" y="1143000"/>
            <a:ext cx="3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606"/>
          <p:cNvSpPr/>
          <p:nvPr/>
        </p:nvSpPr>
        <p:spPr>
          <a:xfrm>
            <a:off x="912960" y="7159680"/>
            <a:ext cx="31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tângulo 43"/>
          <p:cNvSpPr/>
          <p:nvPr/>
        </p:nvSpPr>
        <p:spPr>
          <a:xfrm>
            <a:off x="912960" y="7162920"/>
            <a:ext cx="4952880" cy="243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tângulo 44"/>
          <p:cNvSpPr/>
          <p:nvPr/>
        </p:nvSpPr>
        <p:spPr>
          <a:xfrm>
            <a:off x="912960" y="5257800"/>
            <a:ext cx="4952880" cy="1905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tângulo 45"/>
          <p:cNvSpPr/>
          <p:nvPr/>
        </p:nvSpPr>
        <p:spPr>
          <a:xfrm>
            <a:off x="912960" y="3352680"/>
            <a:ext cx="4952880" cy="1905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9"/>
          <p:cNvSpPr/>
          <p:nvPr/>
        </p:nvSpPr>
        <p:spPr>
          <a:xfrm>
            <a:off x="2929320" y="55627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9"/>
          <p:cNvSpPr/>
          <p:nvPr/>
        </p:nvSpPr>
        <p:spPr>
          <a:xfrm>
            <a:off x="2821320" y="55627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6"/>
          <p:cNvSpPr/>
          <p:nvPr/>
        </p:nvSpPr>
        <p:spPr>
          <a:xfrm>
            <a:off x="2897280" y="354960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6"/>
          <p:cNvSpPr/>
          <p:nvPr/>
        </p:nvSpPr>
        <p:spPr>
          <a:xfrm>
            <a:off x="2213280" y="324468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26"/>
          <p:cNvSpPr/>
          <p:nvPr/>
        </p:nvSpPr>
        <p:spPr>
          <a:xfrm>
            <a:off x="2822760" y="728352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29"/>
          <p:cNvSpPr/>
          <p:nvPr/>
        </p:nvSpPr>
        <p:spPr>
          <a:xfrm>
            <a:off x="2090880" y="79390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29"/>
          <p:cNvSpPr/>
          <p:nvPr/>
        </p:nvSpPr>
        <p:spPr>
          <a:xfrm>
            <a:off x="2211480" y="79246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9"/>
          <p:cNvSpPr/>
          <p:nvPr/>
        </p:nvSpPr>
        <p:spPr>
          <a:xfrm>
            <a:off x="2897280" y="80773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29"/>
          <p:cNvSpPr/>
          <p:nvPr/>
        </p:nvSpPr>
        <p:spPr>
          <a:xfrm>
            <a:off x="1481400" y="80773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26"/>
          <p:cNvSpPr/>
          <p:nvPr/>
        </p:nvSpPr>
        <p:spPr>
          <a:xfrm>
            <a:off x="2592720" y="606420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26"/>
          <p:cNvSpPr/>
          <p:nvPr/>
        </p:nvSpPr>
        <p:spPr>
          <a:xfrm>
            <a:off x="2213280" y="601992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362320" y="990720"/>
            <a:ext cx="2444760" cy="251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198240" y="3017880"/>
            <a:ext cx="837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Days post inoculatio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994200" y="1143000"/>
            <a:ext cx="2178000" cy="224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889520" y="3017880"/>
            <a:ext cx="861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Days post inoculation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"/>
          <p:cNvGrpSpPr/>
          <p:nvPr/>
        </p:nvGrpSpPr>
        <p:grpSpPr>
          <a:xfrm>
            <a:off x="4497480" y="1523880"/>
            <a:ext cx="1368000" cy="1472400"/>
            <a:chOff x="4497480" y="1523880"/>
            <a:chExt cx="1368000" cy="1472400"/>
          </a:xfrm>
        </p:grpSpPr>
        <p:graphicFrame>
          <p:nvGraphicFramePr>
            <p:cNvPr id="91" name="Object 35"/>
            <p:cNvGraphicFramePr/>
            <p:nvPr/>
          </p:nvGraphicFramePr>
          <p:xfrm>
            <a:off x="4570560" y="1523880"/>
            <a:ext cx="761760" cy="646200"/>
          </p:xfrm>
          <a:graphic>
            <a:graphicData uri="http://schemas.openxmlformats.org/presentationml/2006/ole">
              <p:oleObj r:id="rId19" spid="">
                <p:embed/>
                <p:pic>
                  <p:nvPicPr>
                    <p:cNvPr id="92" name="Object 35" descr=""/>
                    <p:cNvPicPr/>
                    <p:nvPr/>
                  </p:nvPicPr>
                  <p:blipFill>
                    <a:blip r:embed="rId20"/>
                    <a:stretch/>
                  </p:blipFill>
                  <p:spPr>
                    <a:xfrm>
                      <a:off x="4570560" y="1523880"/>
                      <a:ext cx="761760" cy="646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3" name="Text Box 29"/>
            <p:cNvSpPr/>
            <p:nvPr/>
          </p:nvSpPr>
          <p:spPr>
            <a:xfrm>
              <a:off x="5596200" y="202788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26"/>
            <p:cNvSpPr/>
            <p:nvPr/>
          </p:nvSpPr>
          <p:spPr>
            <a:xfrm>
              <a:off x="4802400" y="2170080"/>
              <a:ext cx="299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29"/>
            <p:cNvSpPr/>
            <p:nvPr/>
          </p:nvSpPr>
          <p:spPr>
            <a:xfrm>
              <a:off x="5107320" y="179316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29"/>
            <p:cNvSpPr/>
            <p:nvPr/>
          </p:nvSpPr>
          <p:spPr>
            <a:xfrm>
              <a:off x="5215320" y="16218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686480" y="1621800"/>
              <a:ext cx="1143000" cy="1174320"/>
            </a:xfrm>
            <a:prstGeom prst="rect">
              <a:avLst/>
            </a:prstGeom>
            <a:solidFill>
              <a:srgbClr val="ffffff"/>
            </a:solidFill>
            <a:ln w="1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686480" y="2796480"/>
              <a:ext cx="1143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V="1">
              <a:off x="4876920" y="2796120"/>
              <a:ext cx="0" cy="47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V="1">
              <a:off x="5257800" y="2796120"/>
              <a:ext cx="0" cy="47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5638680" y="2796120"/>
              <a:ext cx="0" cy="47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851360" y="28893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5208480" y="2889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589720" y="2889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686480" y="1621800"/>
              <a:ext cx="1143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4686480" y="1621800"/>
              <a:ext cx="0" cy="11743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640400" y="279648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640400" y="263988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640400" y="248292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4640400" y="232632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640400" y="217008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640400" y="201312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640400" y="185652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640400" y="170028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546440" y="2745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546440" y="25891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546440" y="24325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546440" y="22759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546440" y="21193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497480" y="1962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497480" y="1806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497480" y="1649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5829480" y="1621800"/>
              <a:ext cx="0" cy="11743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751280" y="2775240"/>
              <a:ext cx="61920" cy="20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V="1">
              <a:off x="4751280" y="2775240"/>
              <a:ext cx="61920" cy="20880"/>
            </a:xfrm>
            <a:custGeom>
              <a:avLst/>
              <a:gdLst/>
              <a:ahLst/>
              <a:rect l="l" t="t" r="r" b="b"/>
              <a:pathLst>
                <a:path w="138" h="45">
                  <a:moveTo>
                    <a:pt x="138" y="0"/>
                  </a:moveTo>
                  <a:lnTo>
                    <a:pt x="138" y="45"/>
                  </a:lnTo>
                  <a:lnTo>
                    <a:pt x="0" y="45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flipV="1">
              <a:off x="4782960" y="2770200"/>
              <a:ext cx="0" cy="5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759200" y="277020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132520" y="2721240"/>
              <a:ext cx="61920" cy="74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V="1">
              <a:off x="5132520" y="2721240"/>
              <a:ext cx="61920" cy="74880"/>
            </a:xfrm>
            <a:custGeom>
              <a:avLst/>
              <a:gdLst/>
              <a:ahLst/>
              <a:rect l="l" t="t" r="r" b="b"/>
              <a:pathLst>
                <a:path w="137" h="158">
                  <a:moveTo>
                    <a:pt x="137" y="0"/>
                  </a:moveTo>
                  <a:lnTo>
                    <a:pt x="137" y="158"/>
                  </a:lnTo>
                  <a:lnTo>
                    <a:pt x="0" y="158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5162400" y="2721240"/>
              <a:ext cx="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5140440" y="272124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5513400" y="2792880"/>
              <a:ext cx="61920" cy="3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5513400" y="2792160"/>
              <a:ext cx="61920" cy="3240"/>
            </a:xfrm>
            <a:custGeom>
              <a:avLst/>
              <a:gdLst/>
              <a:ahLst/>
              <a:rect l="l" t="t" r="r" b="b"/>
              <a:pathLst>
                <a:path w="137" h="4">
                  <a:moveTo>
                    <a:pt x="137" y="0"/>
                  </a:moveTo>
                  <a:lnTo>
                    <a:pt x="137" y="4"/>
                  </a:lnTo>
                  <a:lnTo>
                    <a:pt x="0" y="4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813200" y="2776680"/>
              <a:ext cx="63720" cy="19440"/>
            </a:xfrm>
            <a:prstGeom prst="rect">
              <a:avLst/>
            </a:prstGeom>
            <a:blipFill rotWithShape="0">
              <a:blip r:embed="rId21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4813200" y="2776680"/>
              <a:ext cx="63720" cy="19440"/>
            </a:xfrm>
            <a:custGeom>
              <a:avLst/>
              <a:gdLst/>
              <a:ahLst/>
              <a:rect l="l" t="t" r="r" b="b"/>
              <a:pathLst>
                <a:path w="137" h="41">
                  <a:moveTo>
                    <a:pt x="137" y="0"/>
                  </a:moveTo>
                  <a:lnTo>
                    <a:pt x="137" y="41"/>
                  </a:lnTo>
                  <a:lnTo>
                    <a:pt x="0" y="41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360" bIns="-27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V="1">
              <a:off x="4844880" y="2771640"/>
              <a:ext cx="0" cy="46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822920" y="277200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5194440" y="2083320"/>
              <a:ext cx="63360" cy="712800"/>
            </a:xfrm>
            <a:prstGeom prst="rect">
              <a:avLst/>
            </a:prstGeom>
            <a:blipFill rotWithShape="0">
              <a:blip r:embed="rId22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5194440" y="2083320"/>
              <a:ext cx="63360" cy="712800"/>
            </a:xfrm>
            <a:custGeom>
              <a:avLst/>
              <a:gdLst/>
              <a:ahLst/>
              <a:rect l="l" t="t" r="r" b="b"/>
              <a:pathLst>
                <a:path w="138" h="1514">
                  <a:moveTo>
                    <a:pt x="138" y="0"/>
                  </a:moveTo>
                  <a:lnTo>
                    <a:pt x="138" y="1514"/>
                  </a:lnTo>
                  <a:lnTo>
                    <a:pt x="0" y="1514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flipV="1">
              <a:off x="5226120" y="2057040"/>
              <a:ext cx="0" cy="259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5203800" y="205704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5575320" y="1770120"/>
              <a:ext cx="63360" cy="1026000"/>
            </a:xfrm>
            <a:prstGeom prst="rect">
              <a:avLst/>
            </a:prstGeom>
            <a:blipFill rotWithShape="0">
              <a:blip r:embed="rId23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V="1">
              <a:off x="5575320" y="1770120"/>
              <a:ext cx="63360" cy="1026000"/>
            </a:xfrm>
            <a:custGeom>
              <a:avLst/>
              <a:gdLst/>
              <a:ahLst/>
              <a:rect l="l" t="t" r="r" b="b"/>
              <a:pathLst>
                <a:path w="138" h="2181">
                  <a:moveTo>
                    <a:pt x="138" y="0"/>
                  </a:moveTo>
                  <a:lnTo>
                    <a:pt x="138" y="2181"/>
                  </a:lnTo>
                  <a:lnTo>
                    <a:pt x="0" y="2181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flipV="1">
              <a:off x="5607000" y="1668960"/>
              <a:ext cx="0" cy="100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584680" y="166896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5638680" y="2792880"/>
              <a:ext cx="61920" cy="3240"/>
            </a:xfrm>
            <a:prstGeom prst="rect">
              <a:avLst/>
            </a:prstGeom>
            <a:blipFill rotWithShape="0">
              <a:blip r:embed="rId24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5638680" y="2792160"/>
              <a:ext cx="61920" cy="3240"/>
            </a:xfrm>
            <a:custGeom>
              <a:avLst/>
              <a:gdLst/>
              <a:ahLst/>
              <a:rect l="l" t="t" r="r" b="b"/>
              <a:pathLst>
                <a:path w="137" h="4">
                  <a:moveTo>
                    <a:pt x="137" y="0"/>
                  </a:moveTo>
                  <a:lnTo>
                    <a:pt x="137" y="4"/>
                  </a:lnTo>
                  <a:lnTo>
                    <a:pt x="0" y="4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4940280" y="2549880"/>
              <a:ext cx="61920" cy="246240"/>
            </a:xfrm>
            <a:prstGeom prst="rect">
              <a:avLst/>
            </a:prstGeom>
            <a:blipFill rotWithShape="0">
              <a:blip r:embed="rId25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4940280" y="2549880"/>
              <a:ext cx="61920" cy="246240"/>
            </a:xfrm>
            <a:custGeom>
              <a:avLst/>
              <a:gdLst/>
              <a:ahLst/>
              <a:rect l="l" t="t" r="r" b="b"/>
              <a:pathLst>
                <a:path w="137" h="521">
                  <a:moveTo>
                    <a:pt x="137" y="0"/>
                  </a:moveTo>
                  <a:lnTo>
                    <a:pt x="137" y="521"/>
                  </a:lnTo>
                  <a:lnTo>
                    <a:pt x="0" y="521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4970520" y="2536560"/>
              <a:ext cx="0" cy="126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4948200" y="253692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5319720" y="1943280"/>
              <a:ext cx="63360" cy="852840"/>
            </a:xfrm>
            <a:prstGeom prst="rect">
              <a:avLst/>
            </a:prstGeom>
            <a:blipFill rotWithShape="0">
              <a:blip r:embed="rId26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5319720" y="1942560"/>
              <a:ext cx="63360" cy="852840"/>
            </a:xfrm>
            <a:custGeom>
              <a:avLst/>
              <a:gdLst/>
              <a:ahLst/>
              <a:rect l="l" t="t" r="r" b="b"/>
              <a:pathLst>
                <a:path w="138" h="1815">
                  <a:moveTo>
                    <a:pt x="138" y="0"/>
                  </a:moveTo>
                  <a:lnTo>
                    <a:pt x="138" y="1815"/>
                  </a:lnTo>
                  <a:lnTo>
                    <a:pt x="0" y="1815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5351400" y="1936440"/>
              <a:ext cx="0" cy="64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5329080" y="193644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5700600" y="2378520"/>
              <a:ext cx="63720" cy="417600"/>
            </a:xfrm>
            <a:prstGeom prst="rect">
              <a:avLst/>
            </a:prstGeom>
            <a:blipFill rotWithShape="0">
              <a:blip r:embed="rId27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flipV="1">
              <a:off x="5700600" y="2378520"/>
              <a:ext cx="63720" cy="417600"/>
            </a:xfrm>
            <a:custGeom>
              <a:avLst/>
              <a:gdLst/>
              <a:ahLst/>
              <a:rect l="l" t="t" r="r" b="b"/>
              <a:pathLst>
                <a:path w="138" h="887">
                  <a:moveTo>
                    <a:pt x="138" y="0"/>
                  </a:moveTo>
                  <a:lnTo>
                    <a:pt x="138" y="887"/>
                  </a:lnTo>
                  <a:lnTo>
                    <a:pt x="0" y="887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5732640" y="2300040"/>
              <a:ext cx="0" cy="781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710320" y="2300400"/>
              <a:ext cx="46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4686480" y="2796480"/>
              <a:ext cx="1143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161" name=""/>
          <p:cNvGraphicFramePr/>
          <p:nvPr/>
        </p:nvGraphicFramePr>
        <p:xfrm>
          <a:off x="4095720" y="1511280"/>
          <a:ext cx="552600" cy="1384200"/>
        </p:xfrm>
        <a:graphic>
          <a:graphicData uri="http://schemas.openxmlformats.org/presentationml/2006/ole">
            <p:oleObj r:id="rId28" spid="">
              <p:embed/>
              <p:pic>
                <p:nvPicPr>
                  <p:cNvPr id="162" name="" descr=""/>
                  <p:cNvPicPr/>
                  <p:nvPr/>
                </p:nvPicPr>
                <p:blipFill>
                  <a:blip r:embed="rId29"/>
                  <a:stretch/>
                </p:blipFill>
                <p:spPr>
                  <a:xfrm>
                    <a:off x="4095720" y="1511280"/>
                    <a:ext cx="552600" cy="1384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63" name=""/>
          <p:cNvSpPr/>
          <p:nvPr/>
        </p:nvSpPr>
        <p:spPr>
          <a:xfrm>
            <a:off x="685800" y="1066680"/>
            <a:ext cx="2205000" cy="228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1561680" y="3008160"/>
            <a:ext cx="837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Days post inoculatio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5" name=""/>
          <p:cNvGrpSpPr/>
          <p:nvPr/>
        </p:nvGrpSpPr>
        <p:grpSpPr>
          <a:xfrm>
            <a:off x="1091160" y="1547280"/>
            <a:ext cx="1494720" cy="1404360"/>
            <a:chOff x="1091160" y="1547280"/>
            <a:chExt cx="1494720" cy="1404360"/>
          </a:xfrm>
        </p:grpSpPr>
        <p:sp>
          <p:nvSpPr>
            <p:cNvPr id="166" name=""/>
            <p:cNvSpPr/>
            <p:nvPr/>
          </p:nvSpPr>
          <p:spPr>
            <a:xfrm>
              <a:off x="1362240" y="1547640"/>
              <a:ext cx="1176120" cy="1203480"/>
            </a:xfrm>
            <a:prstGeom prst="rect">
              <a:avLst/>
            </a:prstGeom>
            <a:solidFill>
              <a:srgbClr val="ffffff"/>
            </a:solidFill>
            <a:ln w="1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1362240" y="2751120"/>
              <a:ext cx="1176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 flipV="1">
              <a:off x="1362240" y="2751120"/>
              <a:ext cx="0" cy="4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 flipV="1">
              <a:off x="1557360" y="2751120"/>
              <a:ext cx="0" cy="4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flipV="1">
              <a:off x="1754280" y="2751120"/>
              <a:ext cx="0" cy="4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flipV="1">
              <a:off x="1949400" y="2751120"/>
              <a:ext cx="0" cy="4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flipV="1">
              <a:off x="2144880" y="2751120"/>
              <a:ext cx="0" cy="4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flipV="1">
              <a:off x="2341440" y="2751120"/>
              <a:ext cx="0" cy="4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flipV="1">
              <a:off x="2538360" y="2751120"/>
              <a:ext cx="0" cy="47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1336680" y="2844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1531800" y="2844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1728720" y="2844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1924200" y="2844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093760" y="2844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2290680" y="2844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2487600" y="2844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362240" y="1547640"/>
              <a:ext cx="1176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flipV="1">
              <a:off x="1362240" y="1547280"/>
              <a:ext cx="0" cy="120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314360" y="2486160"/>
              <a:ext cx="47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314360" y="2106720"/>
              <a:ext cx="47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314360" y="1728720"/>
              <a:ext cx="47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091160" y="2433600"/>
              <a:ext cx="171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0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1141920" y="20541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1217520" y="16765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 flipV="1">
              <a:off x="2538360" y="1547280"/>
              <a:ext cx="0" cy="120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flipV="1">
              <a:off x="1557360" y="1704240"/>
              <a:ext cx="784080" cy="817560"/>
            </a:xfrm>
            <a:custGeom>
              <a:avLst/>
              <a:gdLst/>
              <a:ahLst/>
              <a:rect l="l" t="t" r="r" b="b"/>
              <a:pathLst>
                <a:path w="1667" h="1700">
                  <a:moveTo>
                    <a:pt x="0" y="0"/>
                  </a:moveTo>
                  <a:lnTo>
                    <a:pt x="209" y="0"/>
                  </a:lnTo>
                  <a:lnTo>
                    <a:pt x="417" y="0"/>
                  </a:lnTo>
                  <a:lnTo>
                    <a:pt x="625" y="1044"/>
                  </a:lnTo>
                  <a:lnTo>
                    <a:pt x="834" y="1495"/>
                  </a:lnTo>
                  <a:lnTo>
                    <a:pt x="1042" y="1700"/>
                  </a:lnTo>
                  <a:lnTo>
                    <a:pt x="1250" y="278"/>
                  </a:lnTo>
                  <a:lnTo>
                    <a:pt x="1459" y="474"/>
                  </a:lnTo>
                  <a:lnTo>
                    <a:pt x="1667" y="474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flipV="1">
              <a:off x="1557360" y="2441160"/>
              <a:ext cx="0" cy="810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1533600" y="244152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1557360" y="2522520"/>
              <a:ext cx="0" cy="1652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1533600" y="268776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1530360" y="2495520"/>
              <a:ext cx="54000" cy="54000"/>
            </a:xfrm>
            <a:prstGeom prst="ellipse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 flipV="1">
              <a:off x="1655640" y="2441160"/>
              <a:ext cx="0" cy="810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1631880" y="244152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1655640" y="2522520"/>
              <a:ext cx="0" cy="1652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1631880" y="268776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1628640" y="2495520"/>
              <a:ext cx="54000" cy="54000"/>
            </a:xfrm>
            <a:prstGeom prst="ellipse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1754280" y="2441160"/>
              <a:ext cx="0" cy="810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1730520" y="244152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1754280" y="2522520"/>
              <a:ext cx="0" cy="1652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1730520" y="268776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1727280" y="2495520"/>
              <a:ext cx="54000" cy="54000"/>
            </a:xfrm>
            <a:prstGeom prst="ellipse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 flipV="1">
              <a:off x="1851120" y="1977840"/>
              <a:ext cx="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1827360" y="197820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1851120" y="2021040"/>
              <a:ext cx="0" cy="568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1827360" y="207792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1825560" y="1992240"/>
              <a:ext cx="52560" cy="55800"/>
            </a:xfrm>
            <a:prstGeom prst="ellipse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flipV="1">
              <a:off x="1949400" y="1780920"/>
              <a:ext cx="0" cy="219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1925640" y="178128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1949400" y="1803240"/>
              <a:ext cx="0" cy="270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1925640" y="183024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1922400" y="1776240"/>
              <a:ext cx="54000" cy="54000"/>
            </a:xfrm>
            <a:prstGeom prst="ellipse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2048040" y="1665360"/>
              <a:ext cx="0" cy="396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2023920" y="1665360"/>
              <a:ext cx="47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2048040" y="1704960"/>
              <a:ext cx="0" cy="50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2023920" y="1755720"/>
              <a:ext cx="478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2021040" y="1676520"/>
              <a:ext cx="54000" cy="55440"/>
            </a:xfrm>
            <a:prstGeom prst="ellipse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flipV="1">
              <a:off x="2144880" y="2287080"/>
              <a:ext cx="0" cy="1018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2122560" y="228744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2144880" y="2389320"/>
              <a:ext cx="0" cy="311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2122560" y="270036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2119320" y="2360520"/>
              <a:ext cx="52560" cy="55800"/>
            </a:xfrm>
            <a:prstGeom prst="ellipse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flipV="1">
              <a:off x="2243160" y="2254320"/>
              <a:ext cx="0" cy="396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2220840" y="225432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2243160" y="2293920"/>
              <a:ext cx="0" cy="525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2220840" y="234648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2217600" y="2266920"/>
              <a:ext cx="52560" cy="54000"/>
            </a:xfrm>
            <a:prstGeom prst="ellipse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 flipV="1">
              <a:off x="2341440" y="2254320"/>
              <a:ext cx="0" cy="396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2317680" y="225432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2341440" y="2293920"/>
              <a:ext cx="0" cy="525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317680" y="2346480"/>
              <a:ext cx="47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2314440" y="2266920"/>
              <a:ext cx="54000" cy="54000"/>
            </a:xfrm>
            <a:prstGeom prst="ellipse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7" name="Text Box 607"/>
          <p:cNvSpPr/>
          <p:nvPr/>
        </p:nvSpPr>
        <p:spPr>
          <a:xfrm>
            <a:off x="2759400" y="11430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38" name="Object 34"/>
          <p:cNvGraphicFramePr/>
          <p:nvPr/>
        </p:nvGraphicFramePr>
        <p:xfrm>
          <a:off x="3046320" y="2071800"/>
          <a:ext cx="1371600" cy="823680"/>
        </p:xfrm>
        <a:graphic>
          <a:graphicData uri="http://schemas.openxmlformats.org/presentationml/2006/ole">
            <p:oleObj r:id="rId30" spid="">
              <p:embed/>
              <p:pic>
                <p:nvPicPr>
                  <p:cNvPr id="239" name="Object 34" descr=""/>
                  <p:cNvPicPr/>
                  <p:nvPr/>
                </p:nvPicPr>
                <p:blipFill>
                  <a:blip r:embed="rId31"/>
                  <a:stretch/>
                </p:blipFill>
                <p:spPr>
                  <a:xfrm>
                    <a:off x="3046320" y="2071800"/>
                    <a:ext cx="1371600" cy="823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40" name="Text Box 26"/>
          <p:cNvSpPr/>
          <p:nvPr/>
        </p:nvSpPr>
        <p:spPr>
          <a:xfrm>
            <a:off x="3125880" y="160020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 Box 29"/>
          <p:cNvSpPr/>
          <p:nvPr/>
        </p:nvSpPr>
        <p:spPr>
          <a:xfrm>
            <a:off x="3310200" y="16146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29"/>
          <p:cNvSpPr/>
          <p:nvPr/>
        </p:nvSpPr>
        <p:spPr>
          <a:xfrm>
            <a:off x="3462480" y="16002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 Box 29"/>
          <p:cNvSpPr/>
          <p:nvPr/>
        </p:nvSpPr>
        <p:spPr>
          <a:xfrm>
            <a:off x="3996000" y="19954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 Box 26"/>
          <p:cNvSpPr/>
          <p:nvPr/>
        </p:nvSpPr>
        <p:spPr>
          <a:xfrm>
            <a:off x="3964320" y="156852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005280" y="1625760"/>
            <a:ext cx="1180800" cy="1179360"/>
          </a:xfrm>
          <a:prstGeom prst="rect">
            <a:avLst/>
          </a:prstGeom>
          <a:solidFill>
            <a:srgbClr val="ffffff"/>
          </a:solidFill>
          <a:ln w="1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3005280" y="2805120"/>
            <a:ext cx="11808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 flipV="1">
            <a:off x="3005280" y="2805120"/>
            <a:ext cx="0" cy="47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 flipV="1">
            <a:off x="3189240" y="2805120"/>
            <a:ext cx="0" cy="47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 flipV="1">
            <a:off x="3373560" y="2805120"/>
            <a:ext cx="0" cy="47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flipV="1">
            <a:off x="3557520" y="2805120"/>
            <a:ext cx="0" cy="47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 flipV="1">
            <a:off x="3743280" y="2805120"/>
            <a:ext cx="0" cy="47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 flipV="1">
            <a:off x="3927600" y="2805120"/>
            <a:ext cx="0" cy="47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flipV="1">
            <a:off x="4111560" y="2805120"/>
            <a:ext cx="0" cy="47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2979720" y="28972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3164040" y="28972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3322800" y="28972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3506760" y="28972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3692520" y="28972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3876840" y="28972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4060800" y="28972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3005280" y="1625760"/>
            <a:ext cx="11808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 flipV="1">
            <a:off x="3005280" y="1625760"/>
            <a:ext cx="0" cy="1179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2957400" y="2805120"/>
            <a:ext cx="47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2957400" y="2608200"/>
            <a:ext cx="47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2957400" y="2411280"/>
            <a:ext cx="47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2957400" y="2214720"/>
            <a:ext cx="47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2957400" y="2017800"/>
            <a:ext cx="47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2957400" y="1820880"/>
            <a:ext cx="47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2957400" y="1625760"/>
            <a:ext cx="478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2860560" y="27543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2809800" y="255744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2809800" y="236052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2809800" y="216360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2809800" y="196704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2759400" y="1770120"/>
            <a:ext cx="146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2759400" y="1573200"/>
            <a:ext cx="146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 flipV="1">
            <a:off x="4186080" y="1625760"/>
            <a:ext cx="0" cy="1179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 flipV="1">
            <a:off x="3005280" y="1853640"/>
            <a:ext cx="1106280" cy="950760"/>
          </a:xfrm>
          <a:custGeom>
            <a:avLst/>
            <a:gdLst/>
            <a:ahLst/>
            <a:rect l="l" t="t" r="r" b="b"/>
            <a:pathLst>
              <a:path w="2343" h="2015">
                <a:moveTo>
                  <a:pt x="0" y="0"/>
                </a:moveTo>
                <a:lnTo>
                  <a:pt x="312" y="161"/>
                </a:lnTo>
                <a:lnTo>
                  <a:pt x="625" y="821"/>
                </a:lnTo>
                <a:lnTo>
                  <a:pt x="937" y="2003"/>
                </a:lnTo>
                <a:lnTo>
                  <a:pt x="1250" y="1944"/>
                </a:lnTo>
                <a:lnTo>
                  <a:pt x="2343" y="2015"/>
                </a:lnTo>
              </a:path>
            </a:pathLst>
          </a:custGeom>
          <a:noFill/>
          <a:ln w="3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 flipV="1">
            <a:off x="3005280" y="1863000"/>
            <a:ext cx="1106280" cy="941400"/>
          </a:xfrm>
          <a:custGeom>
            <a:avLst/>
            <a:gdLst/>
            <a:ahLst/>
            <a:rect l="l" t="t" r="r" b="b"/>
            <a:pathLst>
              <a:path w="2343" h="1995">
                <a:moveTo>
                  <a:pt x="0" y="0"/>
                </a:moveTo>
                <a:lnTo>
                  <a:pt x="312" y="334"/>
                </a:lnTo>
                <a:lnTo>
                  <a:pt x="625" y="1671"/>
                </a:lnTo>
                <a:lnTo>
                  <a:pt x="937" y="1995"/>
                </a:lnTo>
                <a:lnTo>
                  <a:pt x="1250" y="1990"/>
                </a:lnTo>
                <a:lnTo>
                  <a:pt x="2343" y="999"/>
                </a:lnTo>
              </a:path>
            </a:pathLst>
          </a:custGeom>
          <a:noFill/>
          <a:ln w="3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2976480" y="2776680"/>
            <a:ext cx="57240" cy="56880"/>
          </a:xfrm>
          <a:prstGeom prst="ellipse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 flipV="1">
            <a:off x="3152880" y="2590560"/>
            <a:ext cx="0" cy="137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3129120" y="259092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152880" y="2728800"/>
            <a:ext cx="0" cy="763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3124080" y="2700360"/>
            <a:ext cx="57240" cy="57240"/>
          </a:xfrm>
          <a:prstGeom prst="ellipse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 flipV="1">
            <a:off x="3300480" y="2354400"/>
            <a:ext cx="0" cy="63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276720" y="235440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3300480" y="2417760"/>
            <a:ext cx="0" cy="61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3276720" y="247968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3271680" y="2389320"/>
            <a:ext cx="57240" cy="56880"/>
          </a:xfrm>
          <a:prstGeom prst="ellipse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3419640" y="1830240"/>
            <a:ext cx="56880" cy="57240"/>
          </a:xfrm>
          <a:prstGeom prst="ellipse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3567240" y="1859040"/>
            <a:ext cx="56880" cy="57240"/>
          </a:xfrm>
          <a:prstGeom prst="ellipse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 flipV="1">
            <a:off x="4111560" y="1847880"/>
            <a:ext cx="0" cy="6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4087800" y="184788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4111560" y="1854360"/>
            <a:ext cx="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4087800" y="186048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4084560" y="1825560"/>
            <a:ext cx="55800" cy="57240"/>
          </a:xfrm>
          <a:prstGeom prst="ellipse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2981160" y="2779560"/>
            <a:ext cx="49320" cy="49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 flipV="1">
            <a:off x="3152880" y="2603160"/>
            <a:ext cx="0" cy="44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3129120" y="260352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3152880" y="2647800"/>
            <a:ext cx="0" cy="44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3129120" y="269244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3127320" y="2622600"/>
            <a:ext cx="50760" cy="49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 flipV="1">
            <a:off x="3300480" y="1861920"/>
            <a:ext cx="0" cy="153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3276720" y="186228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3300480" y="2016000"/>
            <a:ext cx="0" cy="155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3276720" y="217188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3276720" y="1992240"/>
            <a:ext cx="48960" cy="49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 flipV="1">
            <a:off x="3448080" y="1854360"/>
            <a:ext cx="0" cy="9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3424320" y="185436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3448080" y="1863720"/>
            <a:ext cx="0" cy="9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424320" y="187308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3422520" y="1838160"/>
            <a:ext cx="50760" cy="49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 flipV="1">
            <a:off x="3595680" y="1842840"/>
            <a:ext cx="0" cy="219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3571920" y="184320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3595680" y="1865160"/>
            <a:ext cx="0" cy="24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3571920" y="188928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3571920" y="1841400"/>
            <a:ext cx="49320" cy="49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 flipV="1">
            <a:off x="4111560" y="2260080"/>
            <a:ext cx="0" cy="73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4087800" y="226044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4111560" y="2333520"/>
            <a:ext cx="0" cy="73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4087800" y="2406600"/>
            <a:ext cx="47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4087800" y="2308320"/>
            <a:ext cx="49320" cy="489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" bIns="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 rot="5400000">
            <a:off x="4160520" y="2459880"/>
            <a:ext cx="38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 rot="5400000">
            <a:off x="4160520" y="2075760"/>
            <a:ext cx="38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 rot="5400000">
            <a:off x="4143600" y="1749240"/>
            <a:ext cx="51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 rot="5400000">
            <a:off x="4160520" y="1729800"/>
            <a:ext cx="38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 rot="5400000">
            <a:off x="4165560" y="167364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 rot="16200000">
            <a:off x="2383560" y="2160720"/>
            <a:ext cx="613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700" spc="-1" strike="noStrike">
                <a:solidFill>
                  <a:srgbClr val="000000"/>
                </a:solidFill>
                <a:latin typeface="Arial"/>
              </a:rPr>
              <a:t>Cytotoxicity (%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29" name=""/>
          <p:cNvGraphicFramePr/>
          <p:nvPr/>
        </p:nvGraphicFramePr>
        <p:xfrm>
          <a:off x="685800" y="1447920"/>
          <a:ext cx="587520" cy="1395360"/>
        </p:xfrm>
        <a:graphic>
          <a:graphicData uri="http://schemas.openxmlformats.org/presentationml/2006/ole">
            <p:oleObj r:id="rId32" spid="">
              <p:embed/>
              <p:pic>
                <p:nvPicPr>
                  <p:cNvPr id="330" name="" descr=""/>
                  <p:cNvPicPr/>
                  <p:nvPr/>
                </p:nvPicPr>
                <p:blipFill>
                  <a:blip r:embed="rId33"/>
                  <a:stretch/>
                </p:blipFill>
                <p:spPr>
                  <a:xfrm>
                    <a:off x="685800" y="1447920"/>
                    <a:ext cx="587520" cy="1395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31" name="Text Box 606"/>
          <p:cNvSpPr/>
          <p:nvPr/>
        </p:nvSpPr>
        <p:spPr>
          <a:xfrm>
            <a:off x="990720" y="1143000"/>
            <a:ext cx="31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 Box 29"/>
          <p:cNvSpPr/>
          <p:nvPr/>
        </p:nvSpPr>
        <p:spPr>
          <a:xfrm>
            <a:off x="3310200" y="15699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 Box 29"/>
          <p:cNvSpPr/>
          <p:nvPr/>
        </p:nvSpPr>
        <p:spPr>
          <a:xfrm>
            <a:off x="3462480" y="15559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 Box 29"/>
          <p:cNvSpPr/>
          <p:nvPr/>
        </p:nvSpPr>
        <p:spPr>
          <a:xfrm>
            <a:off x="3964320" y="19512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 Box 26"/>
          <p:cNvSpPr/>
          <p:nvPr/>
        </p:nvSpPr>
        <p:spPr>
          <a:xfrm>
            <a:off x="3964320" y="152388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36" name="Object 34"/>
          <p:cNvGraphicFramePr/>
          <p:nvPr/>
        </p:nvGraphicFramePr>
        <p:xfrm>
          <a:off x="3048120" y="2147760"/>
          <a:ext cx="1371600" cy="824040"/>
        </p:xfrm>
        <a:graphic>
          <a:graphicData uri="http://schemas.openxmlformats.org/presentationml/2006/ole">
            <p:oleObj r:id="rId34" spid="">
              <p:embed/>
              <p:pic>
                <p:nvPicPr>
                  <p:cNvPr id="337" name="Object 34" descr=""/>
                  <p:cNvPicPr/>
                  <p:nvPr/>
                </p:nvPicPr>
                <p:blipFill>
                  <a:blip r:embed="rId35"/>
                  <a:stretch/>
                </p:blipFill>
                <p:spPr>
                  <a:xfrm>
                    <a:off x="3048120" y="2147760"/>
                    <a:ext cx="1371600" cy="824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38" name="Object 35"/>
          <p:cNvGraphicFramePr/>
          <p:nvPr/>
        </p:nvGraphicFramePr>
        <p:xfrm>
          <a:off x="4570560" y="1504800"/>
          <a:ext cx="761760" cy="628920"/>
        </p:xfrm>
        <a:graphic>
          <a:graphicData uri="http://schemas.openxmlformats.org/presentationml/2006/ole">
            <p:oleObj r:id="rId36" spid="">
              <p:embed/>
              <p:pic>
                <p:nvPicPr>
                  <p:cNvPr id="339" name="Object 35" descr=""/>
                  <p:cNvPicPr/>
                  <p:nvPr/>
                </p:nvPicPr>
                <p:blipFill>
                  <a:blip r:embed="rId37"/>
                  <a:stretch/>
                </p:blipFill>
                <p:spPr>
                  <a:xfrm>
                    <a:off x="4570560" y="1504800"/>
                    <a:ext cx="761760" cy="628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40" name="Text Box 29"/>
          <p:cNvSpPr/>
          <p:nvPr/>
        </p:nvSpPr>
        <p:spPr>
          <a:xfrm>
            <a:off x="5596200" y="19954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26"/>
          <p:cNvSpPr/>
          <p:nvPr/>
        </p:nvSpPr>
        <p:spPr>
          <a:xfrm>
            <a:off x="4802400" y="213372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 Box 26"/>
          <p:cNvSpPr/>
          <p:nvPr/>
        </p:nvSpPr>
        <p:spPr>
          <a:xfrm>
            <a:off x="5440680" y="129528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 Box 29"/>
          <p:cNvSpPr/>
          <p:nvPr/>
        </p:nvSpPr>
        <p:spPr>
          <a:xfrm>
            <a:off x="5107320" y="17668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 Box 29"/>
          <p:cNvSpPr/>
          <p:nvPr/>
        </p:nvSpPr>
        <p:spPr>
          <a:xfrm>
            <a:off x="5215320" y="16002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2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9T22:53:37Z</dcterms:created>
  <dc:creator>Mauricio</dc:creator>
  <dc:description/>
  <dc:language>en-US</dc:language>
  <cp:lastModifiedBy>Mauricio</cp:lastModifiedBy>
  <dcterms:modified xsi:type="dcterms:W3CDTF">2012-04-06T00:42:41Z</dcterms:modified>
  <cp:revision>588</cp:revision>
  <dc:subject/>
  <dc:title>Slide 1</dc:title>
</cp:coreProperties>
</file>